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76CCE59-B72B-496C-BF6C-B2DDC98E3D44}" v="2" dt="2025-06-23T12:44:34.9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72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 Bannon" userId="c16b13e7d52c6df6" providerId="LiveId" clId="{976CCE59-B72B-496C-BF6C-B2DDC98E3D44}"/>
    <pc:docChg chg="modSld">
      <pc:chgData name="Chris Bannon" userId="c16b13e7d52c6df6" providerId="LiveId" clId="{976CCE59-B72B-496C-BF6C-B2DDC98E3D44}" dt="2025-06-24T10:59:22.132" v="68" actId="20577"/>
      <pc:docMkLst>
        <pc:docMk/>
      </pc:docMkLst>
      <pc:sldChg chg="addSp modSp mod modNotes">
        <pc:chgData name="Chris Bannon" userId="c16b13e7d52c6df6" providerId="LiveId" clId="{976CCE59-B72B-496C-BF6C-B2DDC98E3D44}" dt="2025-06-24T10:59:22.132" v="68" actId="20577"/>
        <pc:sldMkLst>
          <pc:docMk/>
          <pc:sldMk cId="0" sldId="257"/>
        </pc:sldMkLst>
        <pc:spChg chg="mod">
          <ac:chgData name="Chris Bannon" userId="c16b13e7d52c6df6" providerId="LiveId" clId="{976CCE59-B72B-496C-BF6C-B2DDC98E3D44}" dt="2025-06-24T10:59:22.132" v="68" actId="20577"/>
          <ac:spMkLst>
            <pc:docMk/>
            <pc:sldMk cId="0" sldId="257"/>
            <ac:spMk id="91" creationId="{00000000-0000-0000-0000-000000000000}"/>
          </ac:spMkLst>
        </pc:spChg>
        <pc:spChg chg="mod">
          <ac:chgData name="Chris Bannon" userId="c16b13e7d52c6df6" providerId="LiveId" clId="{976CCE59-B72B-496C-BF6C-B2DDC98E3D44}" dt="2025-06-23T12:45:02.757" v="49" actId="2711"/>
          <ac:spMkLst>
            <pc:docMk/>
            <pc:sldMk cId="0" sldId="257"/>
            <ac:spMk id="93" creationId="{00000000-0000-0000-0000-000000000000}"/>
          </ac:spMkLst>
        </pc:spChg>
        <pc:picChg chg="add mod">
          <ac:chgData name="Chris Bannon" userId="c16b13e7d52c6df6" providerId="LiveId" clId="{976CCE59-B72B-496C-BF6C-B2DDC98E3D44}" dt="2025-06-23T12:42:37.577" v="7" actId="1076"/>
          <ac:picMkLst>
            <pc:docMk/>
            <pc:sldMk cId="0" sldId="257"/>
            <ac:picMk id="3" creationId="{E540C8DB-B65B-8708-D9C0-C895A8EB394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92A859-7FCF-4A0A-A8FF-0478645E79FB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C49846-8E02-42BE-AF4A-8DE26E110B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01298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D0AD56-DB78-91C0-0B9C-FA1E1C9B64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728215-5201-0D82-88FB-C7DEDBE778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5FDB0-5F1E-D601-F080-DC61C5974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9B05A-E955-4E10-DC76-25B3F37AC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E09542-CB71-6102-9CE5-B9A4A3CD2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593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AEC2D7-C932-E6B3-B576-A5E11F25E7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079595-22E0-3289-3EC2-A37585740A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58EF92-5831-DE27-D0DA-1AC70249F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F6B35-58B8-9E6C-025E-9FEAC77D4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4AAC5B-5704-B2EE-CD64-B4EB16E0D6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314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B24A8D-F472-4578-9263-0D64BA517F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2BA9A0-8FCC-212D-CD21-D647D6E29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2EA6B1-C1C3-E2DD-2E86-D4887450D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D5E6FB-99CF-0CFA-3AF5-A6C881421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1EE2F3-E518-CA8C-B0B0-F91B2D485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828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9A0776-B461-1EDD-6DCA-0C6BEE3005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0F6922-170D-E31C-D0B6-2457E9525E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35FD46-F0E2-1A7E-0E60-9A26B0063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B3840-29FA-8987-6C55-D4B05C76C2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065BC1-6537-BD9B-56D3-723F92182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1675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20B64-39E3-5B93-F1D6-1E1F5ECC1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E0DC17-828C-6332-BC1F-28348AC9FC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85CA22-49C5-4D9B-D900-5493D08D23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EA6FE4-A106-6F4B-B013-1C3D1742D2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5383A-CB7A-BBC0-1602-6FA2BCDF8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317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D769CD-1212-FEC6-0D70-CD29C425AB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46C7B3-D715-56CA-1615-2BAB32D7B6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3AC982-A7EE-4957-E676-3CC66F68CE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2891F1-7A9E-192E-04A6-8904F3706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5628C7-0AA6-2AF4-82A3-A68BA2B81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2C3B77-BC0F-23A7-55FB-DFE1C3F92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886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BA5E5-FC73-DC85-DC5B-0AE7E93E0A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A533D8-FD7E-EA30-8315-128002DB42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05F2B4-8B38-9551-2345-80931F5462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5FA33C-2061-6B57-C0FF-1FC1491C90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CBF8A5-31D5-431E-6380-47D28A5405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F75ABA-F5C2-F7E0-81DE-EC3C285AC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2D34D4-A047-8335-ECB8-88856A0C9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D389F7-A0C6-6DFB-D5B9-EBF821D2C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743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CE0E2-ACA1-D82D-5FDC-8F3C1877BD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ACC1555-4D97-7B77-0A54-D73F1EF1D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91C8EF-4EC2-C3BA-80D3-B747A39F1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EB85269-564B-B475-DF48-504800018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742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7654FE-24D9-B38E-071F-EB1FFFE52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9A5C8D-9566-1F18-A1B6-9272981CF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B501ED1-E27D-B234-BA08-8D48230ED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99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7F379F-6214-2AE3-7947-C8A04705F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2517A3-F4CF-5984-76EE-A069D8F23E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66A18C-0A86-7C4D-CB1D-B922B78A08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63A804-7621-DF1B-4CBC-3001B42AC3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C6E677-B9D9-46E3-EB00-ABEBFA5B6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6F5C1B-F5F0-1977-6082-389741C7A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1229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8D0725-4139-163F-97CD-7A35D6B2F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9EB17-0994-1865-F251-598F7425D1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5EA3D1-5FFA-544F-DAF1-C11759A40E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E145BC-C1CA-5C4F-C93F-2D86D8B9E4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F88626-053F-5D2D-E981-2847E6F3B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F6A7D8-2962-13BF-A320-AC70AC1B8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258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745C5C-5ACA-9A68-2D9A-704D759E91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FF6825-568E-2843-4E94-0936CC5E4A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03A4B5-3521-AE59-391F-6FAB5F4267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7097B1-AC0D-446F-A360-7EC571067D14}" type="datetimeFigureOut">
              <a:rPr lang="en-GB" smtClean="0"/>
              <a:t>24/06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E935B2-2D76-0BEA-0A3F-B98CCF4151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EC6E9-7987-9B23-6F76-BB7F19E41F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93C947-4A4A-4AC4-A2A0-379C89868A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4396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27000" y="6119970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100"/>
              <a:buFont typeface="Arial"/>
              <a:buNone/>
            </a:pP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Bannon CA, et al. </a:t>
            </a:r>
            <a:r>
              <a:rPr lang="en-GB" sz="1100" b="0" i="1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202</a:t>
            </a:r>
            <a:r>
              <a:rPr lang="en-GB" sz="1100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. DOI: 10.1136/gut-202</a:t>
            </a:r>
            <a:r>
              <a:rPr lang="en-GB" sz="1100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en-GB" sz="1100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335393</a:t>
            </a:r>
            <a:endParaRPr sz="1100" b="0" i="0" u="none" strike="noStrike" cap="none" dirty="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0" y="32173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364067" y="499533"/>
            <a:ext cx="11667066" cy="9232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ctr"/>
            <a:r>
              <a:rPr lang="en-GB" b="1" u="sng" dirty="0">
                <a:latin typeface="Arial" panose="020B0604020202020204" pitchFamily="34" charset="0"/>
                <a:cs typeface="Arial" panose="020B0604020202020204" pitchFamily="34" charset="0"/>
              </a:rPr>
              <a:t>Insulin like peptide 5 is released in response to bile acid in the rectum and is associated with diarrhoea severity in patients with bile acid diarrhoea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A diagram of a healthy and diarrhea&#10;&#10;AI-generated content may be incorrect.">
            <a:extLst>
              <a:ext uri="{FF2B5EF4-FFF2-40B4-BE49-F238E27FC236}">
                <a16:creationId xmlns:a16="http://schemas.microsoft.com/office/drawing/2014/main" id="{E540C8DB-B65B-8708-D9C0-C895A8EB394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3162" y="1411498"/>
            <a:ext cx="6705676" cy="4693973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9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Arial Black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 Bannon</dc:creator>
  <cp:lastModifiedBy>Chris Bannon</cp:lastModifiedBy>
  <cp:revision>1</cp:revision>
  <dcterms:created xsi:type="dcterms:W3CDTF">2025-06-23T12:37:55Z</dcterms:created>
  <dcterms:modified xsi:type="dcterms:W3CDTF">2025-06-24T10:59:27Z</dcterms:modified>
</cp:coreProperties>
</file>